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4" r:id="rId4"/>
    <p:sldId id="265" r:id="rId5"/>
    <p:sldId id="266" r:id="rId6"/>
    <p:sldId id="267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02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52948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04739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8360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64173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6080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6637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15278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347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25111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91028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645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512BE-9700-4866-91BF-BD20C143E373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FE5DD-CE04-459B-9BAE-1E702911858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97195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800" dirty="0" smtClean="0"/>
              <a:t>Fig</a:t>
            </a:r>
            <a:r>
              <a:rPr lang="en-AU" sz="1800" dirty="0" smtClean="0"/>
              <a:t>. </a:t>
            </a:r>
            <a:r>
              <a:rPr lang="en-AU" sz="1800" dirty="0" smtClean="0"/>
              <a:t>S8A</a:t>
            </a:r>
            <a:r>
              <a:rPr lang="en-AU" sz="1800" dirty="0" smtClean="0"/>
              <a:t>: </a:t>
            </a:r>
            <a:r>
              <a:rPr lang="en-US" sz="1800" i="1" dirty="0"/>
              <a:t>Regions of homology between the B. </a:t>
            </a:r>
            <a:r>
              <a:rPr lang="en-US" sz="1800" i="1" dirty="0" err="1"/>
              <a:t>napus</a:t>
            </a:r>
            <a:r>
              <a:rPr lang="en-US" sz="1800" i="1" dirty="0"/>
              <a:t> FT regions and block C from A. thaliana. Putative binding sites are indicated based on ref . BN_chrC06 is upstream from BnaC06g27090D, BN_chrA07 is upstream from BnaA07g25310D, and BN_chrA02 is upstream from BnaA02g12130D. A corresponding block C region for BnaC02g45250D could not be identified. </a:t>
            </a:r>
            <a:r>
              <a:rPr lang="en-AU" sz="1800" i="1" dirty="0"/>
              <a:t/>
            </a:r>
            <a:br>
              <a:rPr lang="en-AU" sz="1800" i="1" dirty="0"/>
            </a:br>
            <a:endParaRPr lang="en-AU" sz="1800" dirty="0"/>
          </a:p>
        </p:txBody>
      </p:sp>
      <p:pic>
        <p:nvPicPr>
          <p:cNvPr id="6" name="Picture" descr="Regions of homology between the B. napus FT regions and block C from A. thaliana. Putative binding sites are indicated based on ref . BN_chrC06 is upstream from BnaC06g27090D, BN_chrA07 is upstream from BnaA07g25310D, and BN_chrA02 is upstream from BnaA02g12130D. A corresponding block C region for BnaC02g45250D could not be identified. "/>
          <p:cNvPicPr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 bwMode="auto">
          <a:xfrm>
            <a:off x="1605623" y="1600200"/>
            <a:ext cx="5932753" cy="452596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8127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800" dirty="0" smtClean="0"/>
              <a:t>Fig</a:t>
            </a:r>
            <a:r>
              <a:rPr lang="en-AU" sz="1800" dirty="0" smtClean="0"/>
              <a:t>. </a:t>
            </a:r>
            <a:r>
              <a:rPr lang="en-AU" sz="1800" dirty="0" smtClean="0"/>
              <a:t>S8B:</a:t>
            </a:r>
            <a:r>
              <a:rPr lang="en-US" sz="1800" dirty="0"/>
              <a:t>Regions of homology between the B. </a:t>
            </a:r>
            <a:r>
              <a:rPr lang="en-US" sz="1800" dirty="0" err="1"/>
              <a:t>napus</a:t>
            </a:r>
            <a:r>
              <a:rPr lang="en-US" sz="1800" dirty="0"/>
              <a:t> FT regions and block E from A. thaliana. Putative binding sites are indicated based on ref . BN_chrA07 is downstream from BnaA07g25310D, BN_chrC02rnd is downstream from BnaC02g45250D, BN_chrA02 is downstream from BnaA02g12130D and BN_chrC06 is downstream from BnaC06g27090D.</a:t>
            </a:r>
            <a:endParaRPr lang="en-AU" sz="1800" dirty="0"/>
          </a:p>
        </p:txBody>
      </p:sp>
      <p:pic>
        <p:nvPicPr>
          <p:cNvPr id="5" name="Picture" descr="Regions of homology between the B. napus FT regions and block E from A. thaliana. Putative binding sites are indicated based on ref . BN_chrA07 is downstream from BnaA07g25310D, BN_chrC02rnd is downstream from BnaC02g45250D, BN_chrA02 is downstream from BnaA02g12130D and BN_chrC06 is downstream from BnaC06g27090D."/>
          <p:cNvPicPr>
            <a:picLocks noGrp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 bwMode="auto">
          <a:xfrm>
            <a:off x="2350684" y="1600200"/>
            <a:ext cx="4442631" cy="4525963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8216406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57808"/>
            <a:ext cx="8229600" cy="1143000"/>
          </a:xfrm>
        </p:spPr>
        <p:txBody>
          <a:bodyPr>
            <a:noAutofit/>
          </a:bodyPr>
          <a:lstStyle/>
          <a:p>
            <a:r>
              <a:rPr lang="en-AU" sz="1800" dirty="0" smtClean="0"/>
              <a:t>Fig S8C:</a:t>
            </a:r>
            <a:r>
              <a:rPr lang="en-US" sz="1800" i="1" dirty="0"/>
              <a:t>Summary of SNP and </a:t>
            </a:r>
            <a:r>
              <a:rPr lang="en-US" sz="1800" i="1" dirty="0" err="1"/>
              <a:t>Indel</a:t>
            </a:r>
            <a:r>
              <a:rPr lang="en-US" sz="1800" i="1" dirty="0"/>
              <a:t> variation in the B. </a:t>
            </a:r>
            <a:r>
              <a:rPr lang="en-US" sz="1800" i="1" dirty="0" err="1"/>
              <a:t>napus</a:t>
            </a:r>
            <a:r>
              <a:rPr lang="en-US" sz="1800" i="1" dirty="0"/>
              <a:t> FT gene BnaA02g12130D across 21 lines. The gene model is shown below the plot. Key: Insertions=triangle, deletions=inverted triangle, SNPs=dots, red=nonsynonymous change</a:t>
            </a:r>
            <a:r>
              <a:rPr lang="en-AU" sz="1800" i="1" dirty="0"/>
              <a:t/>
            </a:r>
            <a:br>
              <a:rPr lang="en-AU" sz="1800" i="1" dirty="0"/>
            </a:br>
            <a:endParaRPr lang="en-AU" sz="18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40" y="1742727"/>
            <a:ext cx="8316416" cy="3745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62063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354162"/>
          </a:xfrm>
        </p:spPr>
        <p:txBody>
          <a:bodyPr>
            <a:noAutofit/>
          </a:bodyPr>
          <a:lstStyle/>
          <a:p>
            <a:r>
              <a:rPr lang="en-AU" sz="1800" dirty="0" smtClean="0"/>
              <a:t>Fig</a:t>
            </a:r>
            <a:r>
              <a:rPr lang="en-AU" sz="1800" dirty="0" smtClean="0"/>
              <a:t>. </a:t>
            </a:r>
            <a:r>
              <a:rPr lang="en-AU" sz="1800" dirty="0" smtClean="0"/>
              <a:t>S8D</a:t>
            </a:r>
            <a:r>
              <a:rPr lang="en-AU" sz="1800" dirty="0" smtClean="0"/>
              <a:t>: </a:t>
            </a:r>
            <a:r>
              <a:rPr lang="en-US" sz="1800" i="1" dirty="0"/>
              <a:t>Summary of SNP and </a:t>
            </a:r>
            <a:r>
              <a:rPr lang="en-US" sz="1800" i="1" dirty="0" err="1"/>
              <a:t>Indel</a:t>
            </a:r>
            <a:r>
              <a:rPr lang="en-US" sz="1800" i="1" dirty="0"/>
              <a:t> variation in the B. </a:t>
            </a:r>
            <a:r>
              <a:rPr lang="en-US" sz="1800" i="1" dirty="0" err="1"/>
              <a:t>napus</a:t>
            </a:r>
            <a:r>
              <a:rPr lang="en-US" sz="1800" i="1" dirty="0"/>
              <a:t> FT gene BnaA07g25310D across 21 lines. The gene model is shown below the plot. Key: Insertions=triangle, deletions=inverted triangle, SNPs=dots, red=nonsynonymous change</a:t>
            </a:r>
            <a:r>
              <a:rPr lang="en-AU" sz="1800" i="1" dirty="0"/>
              <a:t/>
            </a:r>
            <a:br>
              <a:rPr lang="en-AU" sz="1800" i="1" dirty="0"/>
            </a:br>
            <a:endParaRPr lang="en-AU" sz="18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305" y="1891306"/>
            <a:ext cx="8406143" cy="36259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89686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800" dirty="0" smtClean="0"/>
              <a:t>Fig</a:t>
            </a:r>
            <a:r>
              <a:rPr lang="en-AU" sz="1800" dirty="0" smtClean="0"/>
              <a:t>. </a:t>
            </a:r>
            <a:r>
              <a:rPr lang="en-AU" sz="1800" dirty="0" smtClean="0"/>
              <a:t>S8E</a:t>
            </a:r>
            <a:r>
              <a:rPr lang="en-AU" sz="1800" dirty="0" smtClean="0"/>
              <a:t>: </a:t>
            </a:r>
            <a:r>
              <a:rPr lang="en-US" sz="1800" dirty="0"/>
              <a:t>Summary of SNP and </a:t>
            </a:r>
            <a:r>
              <a:rPr lang="en-US" sz="1800" dirty="0" err="1"/>
              <a:t>Indel</a:t>
            </a:r>
            <a:r>
              <a:rPr lang="en-US" sz="1800" dirty="0"/>
              <a:t> variation in the </a:t>
            </a:r>
            <a:r>
              <a:rPr lang="en-US" sz="1800" i="1" dirty="0"/>
              <a:t>B. </a:t>
            </a:r>
            <a:r>
              <a:rPr lang="en-US" sz="1800" i="1" dirty="0" err="1"/>
              <a:t>napus</a:t>
            </a:r>
            <a:r>
              <a:rPr lang="en-US" sz="1800" i="1" dirty="0"/>
              <a:t> FT</a:t>
            </a:r>
            <a:r>
              <a:rPr lang="en-US" sz="1800" dirty="0"/>
              <a:t> gene </a:t>
            </a:r>
            <a:r>
              <a:rPr lang="en-US" sz="1800" i="1" dirty="0"/>
              <a:t>BnaC02g45250D </a:t>
            </a:r>
            <a:r>
              <a:rPr lang="en-US" sz="1800" dirty="0"/>
              <a:t>across 21 lines. The gene model is shown below the plot. Key: Insertions=triangle, deletions=inverted triangle, SNPs=dots, red=nonsynonymous change</a:t>
            </a:r>
            <a:endParaRPr lang="en-AU" sz="1800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062668"/>
            <a:ext cx="8229600" cy="3601027"/>
          </a:xfrm>
        </p:spPr>
      </p:pic>
    </p:spTree>
    <p:extLst>
      <p:ext uri="{BB962C8B-B14F-4D97-AF65-F5344CB8AC3E}">
        <p14:creationId xmlns:p14="http://schemas.microsoft.com/office/powerpoint/2010/main" val="3678019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800" dirty="0" smtClean="0"/>
              <a:t>Fig</a:t>
            </a:r>
            <a:r>
              <a:rPr lang="en-AU" sz="1800" dirty="0" smtClean="0"/>
              <a:t>. </a:t>
            </a:r>
            <a:r>
              <a:rPr lang="en-AU" sz="1800" dirty="0" smtClean="0"/>
              <a:t>S8F</a:t>
            </a:r>
            <a:r>
              <a:rPr lang="en-AU" sz="1800" dirty="0" smtClean="0"/>
              <a:t>.</a:t>
            </a:r>
            <a:r>
              <a:rPr lang="en-US" sz="1800" dirty="0"/>
              <a:t> Summary of SNP and </a:t>
            </a:r>
            <a:r>
              <a:rPr lang="en-US" sz="1800" dirty="0" err="1"/>
              <a:t>Indel</a:t>
            </a:r>
            <a:r>
              <a:rPr lang="en-US" sz="1800" dirty="0"/>
              <a:t> variation in the </a:t>
            </a:r>
            <a:r>
              <a:rPr lang="en-US" sz="1800" i="1" dirty="0"/>
              <a:t>B. </a:t>
            </a:r>
            <a:r>
              <a:rPr lang="en-US" sz="1800" i="1" dirty="0" err="1"/>
              <a:t>napus</a:t>
            </a:r>
            <a:r>
              <a:rPr lang="en-US" sz="1800" i="1" dirty="0"/>
              <a:t> FT</a:t>
            </a:r>
            <a:r>
              <a:rPr lang="en-US" sz="1800" dirty="0"/>
              <a:t> gene </a:t>
            </a:r>
            <a:r>
              <a:rPr lang="en-US" sz="1800" i="1" dirty="0"/>
              <a:t>BnaC06g27090D </a:t>
            </a:r>
            <a:r>
              <a:rPr lang="en-US" sz="1800" dirty="0"/>
              <a:t>across 21 </a:t>
            </a:r>
            <a:r>
              <a:rPr lang="en-US" sz="1800" dirty="0" smtClean="0"/>
              <a:t>lines. </a:t>
            </a:r>
            <a:r>
              <a:rPr lang="en-US" sz="1800" dirty="0"/>
              <a:t>The gene model is shown below the plot. Key: </a:t>
            </a:r>
            <a:r>
              <a:rPr lang="en-US" sz="1800" dirty="0" smtClean="0"/>
              <a:t>Insertions = triangle</a:t>
            </a:r>
            <a:r>
              <a:rPr lang="en-US" sz="1800" dirty="0"/>
              <a:t>, </a:t>
            </a:r>
            <a:r>
              <a:rPr lang="en-US" sz="1800" dirty="0" smtClean="0"/>
              <a:t>deletions = inverted </a:t>
            </a:r>
            <a:r>
              <a:rPr lang="en-US" sz="1800" dirty="0"/>
              <a:t>triangle, </a:t>
            </a:r>
            <a:r>
              <a:rPr lang="en-US" sz="1800" dirty="0" smtClean="0"/>
              <a:t>SNPs = dots</a:t>
            </a:r>
            <a:r>
              <a:rPr lang="en-US" sz="1800" dirty="0"/>
              <a:t>, </a:t>
            </a:r>
            <a:r>
              <a:rPr lang="en-US" sz="1800" dirty="0" smtClean="0"/>
              <a:t>red = non-synonymous </a:t>
            </a:r>
            <a:r>
              <a:rPr lang="en-US" sz="1800" dirty="0"/>
              <a:t>change</a:t>
            </a:r>
            <a:endParaRPr lang="en-AU" sz="1800" dirty="0"/>
          </a:p>
        </p:txBody>
      </p:sp>
      <p:pic>
        <p:nvPicPr>
          <p:cNvPr id="5" name="Content Placeholder 4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2068783"/>
            <a:ext cx="8229600" cy="3588796"/>
          </a:xfrm>
        </p:spPr>
      </p:pic>
    </p:spTree>
    <p:extLst>
      <p:ext uri="{BB962C8B-B14F-4D97-AF65-F5344CB8AC3E}">
        <p14:creationId xmlns:p14="http://schemas.microsoft.com/office/powerpoint/2010/main" val="305236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290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Fig. S8A: Regions of homology between the B. napus FT regions and block C from A. thaliana. Putative binding sites are indicated based on ref . BN_chrC06 is upstream from BnaC06g27090D, BN_chrA07 is upstream from BnaA07g25310D, and BN_chrA02 is upstream from BnaA02g12130D. A corresponding block C region for BnaC02g45250D could not be identified.  </vt:lpstr>
      <vt:lpstr>Fig. S8B:Regions of homology between the B. napus FT regions and block E from A. thaliana. Putative binding sites are indicated based on ref . BN_chrA07 is downstream from BnaA07g25310D, BN_chrC02rnd is downstream from BnaC02g45250D, BN_chrA02 is downstream from BnaA02g12130D and BN_chrC06 is downstream from BnaC06g27090D.</vt:lpstr>
      <vt:lpstr>Fig S8C:Summary of SNP and Indel variation in the B. napus FT gene BnaA02g12130D across 21 lines. The gene model is shown below the plot. Key: Insertions=triangle, deletions=inverted triangle, SNPs=dots, red=nonsynonymous change </vt:lpstr>
      <vt:lpstr>Fig. S8D: Summary of SNP and Indel variation in the B. napus FT gene BnaA07g25310D across 21 lines. The gene model is shown below the plot. Key: Insertions=triangle, deletions=inverted triangle, SNPs=dots, red=nonsynonymous change </vt:lpstr>
      <vt:lpstr>Fig. S8E: Summary of SNP and Indel variation in the B. napus FT gene BnaC02g45250D across 21 lines. The gene model is shown below the plot. Key: Insertions=triangle, deletions=inverted triangle, SNPs=dots, red=nonsynonymous change</vt:lpstr>
      <vt:lpstr>Fig. S8F. Summary of SNP and Indel variation in the B. napus FT gene BnaC06g27090D across 21 lines. The gene model is shown below the plot. Key: Insertions = triangle, deletions = inverted triangle, SNPs = dots, red = non-synonymous change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. 7A: Regions of homology between the B. napus FT regions and block C from A. thaliana. Putative binding sites are indicated based on ref . BN_chrC06 is upstream from BnaC06g27090D, BN_chrA07 is upstream from BnaA07g25310D, and BN_chrA02 is upstream from BnaA02g12130D. A corresponding block C region for BnaC02g45250D could not be identified.</dc:title>
  <dc:creator>NSW Government User</dc:creator>
  <cp:lastModifiedBy>NSW Government User</cp:lastModifiedBy>
  <cp:revision>11</cp:revision>
  <dcterms:created xsi:type="dcterms:W3CDTF">2019-05-10T06:10:11Z</dcterms:created>
  <dcterms:modified xsi:type="dcterms:W3CDTF">2019-07-17T23:00:23Z</dcterms:modified>
</cp:coreProperties>
</file>